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  <p:sldId id="278" r:id="rId3"/>
    <p:sldId id="279" r:id="rId4"/>
    <p:sldId id="277" r:id="rId5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62626"/>
    <a:srgbClr val="A6A6A6"/>
    <a:srgbClr val="1A1A1A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441" autoAdjust="0"/>
    <p:restoredTop sz="94660"/>
  </p:normalViewPr>
  <p:slideViewPr>
    <p:cSldViewPr snapToGrid="0">
      <p:cViewPr varScale="1">
        <p:scale>
          <a:sx n="79" d="100"/>
          <a:sy n="79" d="100"/>
        </p:scale>
        <p:origin x="366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8745;&#23713;&#22823;&#23398;%20&#26893;&#29289;&#27231;&#33021;&#29983;&#29702;&#23398;&#30740;&#31350;&#23460;\2019&#24180;&#24230;&#23455;&#39443;&#12487;&#12540;&#12479;\&#34987;&#35206;&#33590;PJ\&#34987;&#35206;&#33590;PJ&#36942;&#21435;&#12487;&#12540;&#12479;%20(&#26757;&#27941;&#65292;&#26862;&#30000;)\ICP_&#22303;&#32789;pot&#36899;&#32154;&#34987;&#35206;&#35430;&#39443;%20(2016&#24180;&#24230;&#26757;&#27941;)\&#26757;&#27941;&#25104;&#20998;&#20998;&#26512;&#12414;&#12392;&#12417;_Lastupdate20190801_yamashi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8745;&#23713;&#22823;&#23398;%20&#26893;&#29289;&#27231;&#33021;&#29983;&#29702;&#23398;&#30740;&#31350;&#23460;\2019&#24180;&#24230;&#23455;&#39443;&#12487;&#12540;&#12479;\&#34987;&#35206;&#33590;PJ\&#34987;&#35206;&#33590;PJ&#36942;&#21435;&#12487;&#12540;&#12479;%20(&#26757;&#27941;&#65292;&#26862;&#30000;)\ICP_&#22303;&#32789;pot&#36899;&#32154;&#34987;&#35206;&#35430;&#39443;%20(2016&#24180;&#24230;&#26757;&#27941;)\&#26757;&#27941;&#25104;&#20998;&#20998;&#26512;&#12414;&#12392;&#12417;_Lastupdate20190801_yamashi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イオノーム再!$A$3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イオノーム再!$Q$32:$Q$34</c:f>
                <c:numCache>
                  <c:formatCode>General</c:formatCode>
                  <c:ptCount val="3"/>
                  <c:pt idx="0">
                    <c:v>1.5381832696137245E-2</c:v>
                  </c:pt>
                  <c:pt idx="1">
                    <c:v>1.7619100849738226E-2</c:v>
                  </c:pt>
                  <c:pt idx="2">
                    <c:v>3.4700778943022007E-3</c:v>
                  </c:pt>
                </c:numCache>
              </c:numRef>
            </c:plus>
            <c:minus>
              <c:numRef>
                <c:f>イオノーム再!$Q$32:$Q$34</c:f>
                <c:numCache>
                  <c:formatCode>General</c:formatCode>
                  <c:ptCount val="3"/>
                  <c:pt idx="0">
                    <c:v>1.5381832696137245E-2</c:v>
                  </c:pt>
                  <c:pt idx="1">
                    <c:v>1.7619100849738226E-2</c:v>
                  </c:pt>
                  <c:pt idx="2">
                    <c:v>3.4700778943022007E-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イオノーム再!$D$32:$D$34</c:f>
              <c:numCache>
                <c:formatCode>General</c:formatCode>
                <c:ptCount val="3"/>
                <c:pt idx="0">
                  <c:v>6.998087291959168E-2</c:v>
                </c:pt>
                <c:pt idx="1">
                  <c:v>9.3177610977080674E-2</c:v>
                </c:pt>
                <c:pt idx="2">
                  <c:v>4.7955916265231158E-2</c:v>
                </c:pt>
              </c:numCache>
            </c:numRef>
          </c:val>
        </c:ser>
        <c:ser>
          <c:idx val="1"/>
          <c:order val="1"/>
          <c:tx>
            <c:strRef>
              <c:f>イオノーム再!$A$35</c:f>
              <c:strCache>
                <c:ptCount val="1"/>
                <c:pt idx="0">
                  <c:v>85% Shading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イオノーム再!$Q$35:$Q$37</c:f>
                <c:numCache>
                  <c:formatCode>General</c:formatCode>
                  <c:ptCount val="3"/>
                  <c:pt idx="0">
                    <c:v>1.0371148090498205E-2</c:v>
                  </c:pt>
                  <c:pt idx="1">
                    <c:v>1.6734572624890112E-2</c:v>
                  </c:pt>
                  <c:pt idx="2">
                    <c:v>4.0309009130629955E-3</c:v>
                  </c:pt>
                </c:numCache>
              </c:numRef>
            </c:plus>
            <c:minus>
              <c:numRef>
                <c:f>イオノーム再!$Q$35:$Q$37</c:f>
                <c:numCache>
                  <c:formatCode>General</c:formatCode>
                  <c:ptCount val="3"/>
                  <c:pt idx="0">
                    <c:v>1.0371148090498205E-2</c:v>
                  </c:pt>
                  <c:pt idx="1">
                    <c:v>1.6734572624890112E-2</c:v>
                  </c:pt>
                  <c:pt idx="2">
                    <c:v>4.0309009130629955E-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イオノーム再!$D$35:$D$37</c:f>
              <c:numCache>
                <c:formatCode>General</c:formatCode>
                <c:ptCount val="3"/>
                <c:pt idx="0">
                  <c:v>8.1983518535245672E-2</c:v>
                </c:pt>
                <c:pt idx="1">
                  <c:v>7.0485953009779237E-2</c:v>
                </c:pt>
                <c:pt idx="2">
                  <c:v>8.631891471872384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1033952"/>
        <c:axId val="241034512"/>
      </c:barChart>
      <c:catAx>
        <c:axId val="241033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41034512"/>
        <c:crosses val="autoZero"/>
        <c:auto val="1"/>
        <c:lblAlgn val="ctr"/>
        <c:lblOffset val="100"/>
        <c:noMultiLvlLbl val="1"/>
      </c:catAx>
      <c:valAx>
        <c:axId val="24103451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41033952"/>
        <c:crossesAt val="-10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イオノーム再!$A$3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イオノーム再!$Z$32:$Z$34</c:f>
                <c:numCache>
                  <c:formatCode>General</c:formatCode>
                  <c:ptCount val="3"/>
                  <c:pt idx="0">
                    <c:v>0.2295126798637486</c:v>
                  </c:pt>
                  <c:pt idx="1">
                    <c:v>0.17439896237979308</c:v>
                  </c:pt>
                  <c:pt idx="2">
                    <c:v>0.22660182087415359</c:v>
                  </c:pt>
                </c:numCache>
              </c:numRef>
            </c:plus>
            <c:minus>
              <c:numRef>
                <c:f>イオノーム再!$Z$32:$Z$34</c:f>
                <c:numCache>
                  <c:formatCode>General</c:formatCode>
                  <c:ptCount val="3"/>
                  <c:pt idx="0">
                    <c:v>0.2295126798637486</c:v>
                  </c:pt>
                  <c:pt idx="1">
                    <c:v>0.17439896237979308</c:v>
                  </c:pt>
                  <c:pt idx="2">
                    <c:v>0.22660182087415359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イオノーム再!$M$32:$M$34</c:f>
              <c:numCache>
                <c:formatCode>General</c:formatCode>
                <c:ptCount val="3"/>
                <c:pt idx="0">
                  <c:v>2.5203763746140808</c:v>
                </c:pt>
                <c:pt idx="1">
                  <c:v>3.1940656765809217</c:v>
                </c:pt>
                <c:pt idx="2">
                  <c:v>2.4395940697934577</c:v>
                </c:pt>
              </c:numCache>
            </c:numRef>
          </c:val>
        </c:ser>
        <c:ser>
          <c:idx val="1"/>
          <c:order val="1"/>
          <c:tx>
            <c:strRef>
              <c:f>イオノーム再!$A$35</c:f>
              <c:strCache>
                <c:ptCount val="1"/>
                <c:pt idx="0">
                  <c:v>85% Shading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イオノーム再!$Z$35:$Z$37</c:f>
                <c:numCache>
                  <c:formatCode>General</c:formatCode>
                  <c:ptCount val="3"/>
                  <c:pt idx="0">
                    <c:v>0.14320008697263803</c:v>
                  </c:pt>
                  <c:pt idx="1">
                    <c:v>0.51964990563062041</c:v>
                  </c:pt>
                  <c:pt idx="2">
                    <c:v>0.22558941525524565</c:v>
                  </c:pt>
                </c:numCache>
              </c:numRef>
            </c:plus>
            <c:minus>
              <c:numRef>
                <c:f>イオノーム再!$Z$35:$Z$37</c:f>
                <c:numCache>
                  <c:formatCode>General</c:formatCode>
                  <c:ptCount val="3"/>
                  <c:pt idx="0">
                    <c:v>0.14320008697263803</c:v>
                  </c:pt>
                  <c:pt idx="1">
                    <c:v>0.51964990563062041</c:v>
                  </c:pt>
                  <c:pt idx="2">
                    <c:v>0.2255894152552456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イオノーム再!$M$35:$M$37</c:f>
              <c:numCache>
                <c:formatCode>General</c:formatCode>
                <c:ptCount val="3"/>
                <c:pt idx="0">
                  <c:v>3.4092422028752494</c:v>
                </c:pt>
                <c:pt idx="1">
                  <c:v>2.7473125728312966</c:v>
                </c:pt>
                <c:pt idx="2">
                  <c:v>3.57299444921975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1037312"/>
        <c:axId val="241037872"/>
      </c:barChart>
      <c:catAx>
        <c:axId val="241037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41037872"/>
        <c:crosses val="autoZero"/>
        <c:auto val="1"/>
        <c:lblAlgn val="ctr"/>
        <c:lblOffset val="100"/>
        <c:noMultiLvlLbl val="1"/>
      </c:catAx>
      <c:valAx>
        <c:axId val="24103787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41037312"/>
        <c:crossesAt val="-10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91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745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6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452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526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2819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9511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152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388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666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508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690F6-66A8-41DE-AA78-241C4E90F593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0482F4-143B-46D2-9B20-2735D98539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3968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3"/>
          <p:cNvSpPr>
            <a:spLocks noChangeArrowheads="1"/>
          </p:cNvSpPr>
          <p:nvPr/>
        </p:nvSpPr>
        <p:spPr bwMode="auto">
          <a:xfrm>
            <a:off x="2533776" y="3122420"/>
            <a:ext cx="18473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ja-JP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/>
          <p:cNvCxnSpPr/>
          <p:nvPr/>
        </p:nvCxnSpPr>
        <p:spPr bwMode="auto">
          <a:xfrm>
            <a:off x="4637791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右矢印 6"/>
          <p:cNvSpPr/>
          <p:nvPr/>
        </p:nvSpPr>
        <p:spPr bwMode="auto">
          <a:xfrm>
            <a:off x="3812837" y="2537187"/>
            <a:ext cx="790871" cy="164208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右矢印 7"/>
          <p:cNvSpPr/>
          <p:nvPr/>
        </p:nvSpPr>
        <p:spPr bwMode="auto">
          <a:xfrm>
            <a:off x="1188876" y="2537187"/>
            <a:ext cx="778186" cy="164209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右矢印 8"/>
          <p:cNvSpPr/>
          <p:nvPr/>
        </p:nvSpPr>
        <p:spPr bwMode="auto">
          <a:xfrm>
            <a:off x="1191219" y="2870745"/>
            <a:ext cx="776285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/>
          <p:cNvCxnSpPr/>
          <p:nvPr/>
        </p:nvCxnSpPr>
        <p:spPr bwMode="auto">
          <a:xfrm flipH="1">
            <a:off x="1150988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 bwMode="auto">
          <a:xfrm flipH="1">
            <a:off x="2008826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 bwMode="auto">
          <a:xfrm>
            <a:off x="3767716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33"/>
          <p:cNvSpPr>
            <a:spLocks noChangeArrowheads="1"/>
          </p:cNvSpPr>
          <p:nvPr/>
        </p:nvSpPr>
        <p:spPr bwMode="auto">
          <a:xfrm>
            <a:off x="1223769" y="229874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9" name="正方形/長方形 29"/>
          <p:cNvSpPr>
            <a:spLocks noChangeArrowheads="1"/>
          </p:cNvSpPr>
          <p:nvPr/>
        </p:nvSpPr>
        <p:spPr bwMode="auto">
          <a:xfrm>
            <a:off x="1041638" y="3109127"/>
            <a:ext cx="109517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85% Shading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20" name="右矢印 19"/>
          <p:cNvSpPr/>
          <p:nvPr/>
        </p:nvSpPr>
        <p:spPr bwMode="auto">
          <a:xfrm>
            <a:off x="2061131" y="2537187"/>
            <a:ext cx="790871" cy="164208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33"/>
          <p:cNvSpPr>
            <a:spLocks noChangeArrowheads="1"/>
          </p:cNvSpPr>
          <p:nvPr/>
        </p:nvSpPr>
        <p:spPr bwMode="auto">
          <a:xfrm>
            <a:off x="2979772" y="229874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22" name="右矢印 21"/>
          <p:cNvSpPr/>
          <p:nvPr/>
        </p:nvSpPr>
        <p:spPr bwMode="auto">
          <a:xfrm>
            <a:off x="2935374" y="2537187"/>
            <a:ext cx="778186" cy="164209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右矢印 22"/>
          <p:cNvSpPr/>
          <p:nvPr/>
        </p:nvSpPr>
        <p:spPr bwMode="auto">
          <a:xfrm>
            <a:off x="2937717" y="2870745"/>
            <a:ext cx="776285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/>
          <p:cNvCxnSpPr/>
          <p:nvPr/>
        </p:nvCxnSpPr>
        <p:spPr bwMode="auto">
          <a:xfrm flipH="1">
            <a:off x="2897486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正方形/長方形 33"/>
          <p:cNvSpPr>
            <a:spLocks noChangeArrowheads="1"/>
          </p:cNvSpPr>
          <p:nvPr/>
        </p:nvSpPr>
        <p:spPr bwMode="auto">
          <a:xfrm>
            <a:off x="3862643" y="229874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29" name="右矢印 28"/>
          <p:cNvSpPr/>
          <p:nvPr/>
        </p:nvSpPr>
        <p:spPr bwMode="auto">
          <a:xfrm>
            <a:off x="329311" y="2696592"/>
            <a:ext cx="790871" cy="16420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19183" y="2289765"/>
            <a:ext cx="7493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der </a:t>
            </a:r>
          </a:p>
          <a:p>
            <a:pPr algn="ctr"/>
            <a:r>
              <a:rPr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nlight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/>
          <p:cNvCxnSpPr/>
          <p:nvPr/>
        </p:nvCxnSpPr>
        <p:spPr bwMode="auto">
          <a:xfrm>
            <a:off x="5506035" y="2480403"/>
            <a:ext cx="0" cy="648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右矢印 31"/>
          <p:cNvSpPr/>
          <p:nvPr/>
        </p:nvSpPr>
        <p:spPr bwMode="auto">
          <a:xfrm>
            <a:off x="4681850" y="2537187"/>
            <a:ext cx="778186" cy="164209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右矢印 32"/>
          <p:cNvSpPr/>
          <p:nvPr/>
        </p:nvSpPr>
        <p:spPr bwMode="auto">
          <a:xfrm>
            <a:off x="4684193" y="2870745"/>
            <a:ext cx="776285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右矢印 38"/>
          <p:cNvSpPr/>
          <p:nvPr/>
        </p:nvSpPr>
        <p:spPr bwMode="auto">
          <a:xfrm>
            <a:off x="2062541" y="2870745"/>
            <a:ext cx="776285" cy="164209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右矢印 39"/>
          <p:cNvSpPr/>
          <p:nvPr/>
        </p:nvSpPr>
        <p:spPr bwMode="auto">
          <a:xfrm>
            <a:off x="3821431" y="2870745"/>
            <a:ext cx="776285" cy="164209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33"/>
          <p:cNvSpPr>
            <a:spLocks noChangeArrowheads="1"/>
          </p:cNvSpPr>
          <p:nvPr/>
        </p:nvSpPr>
        <p:spPr bwMode="auto">
          <a:xfrm>
            <a:off x="2091112" y="229874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2" name="正方形/長方形 29"/>
          <p:cNvSpPr>
            <a:spLocks noChangeArrowheads="1"/>
          </p:cNvSpPr>
          <p:nvPr/>
        </p:nvSpPr>
        <p:spPr bwMode="auto">
          <a:xfrm>
            <a:off x="2801677" y="3109127"/>
            <a:ext cx="109517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85% Shading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3" name="正方形/長方形 29"/>
          <p:cNvSpPr>
            <a:spLocks noChangeArrowheads="1"/>
          </p:cNvSpPr>
          <p:nvPr/>
        </p:nvSpPr>
        <p:spPr bwMode="auto">
          <a:xfrm>
            <a:off x="4541034" y="3109127"/>
            <a:ext cx="109517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85% Shading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4" name="正方形/長方形 33"/>
          <p:cNvSpPr>
            <a:spLocks noChangeArrowheads="1"/>
          </p:cNvSpPr>
          <p:nvPr/>
        </p:nvSpPr>
        <p:spPr bwMode="auto">
          <a:xfrm>
            <a:off x="2119216" y="310912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5" name="正方形/長方形 33"/>
          <p:cNvSpPr>
            <a:spLocks noChangeArrowheads="1"/>
          </p:cNvSpPr>
          <p:nvPr/>
        </p:nvSpPr>
        <p:spPr bwMode="auto">
          <a:xfrm>
            <a:off x="3863858" y="310912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6" name="正方形/長方形 33"/>
          <p:cNvSpPr>
            <a:spLocks noChangeArrowheads="1"/>
          </p:cNvSpPr>
          <p:nvPr/>
        </p:nvSpPr>
        <p:spPr bwMode="auto">
          <a:xfrm>
            <a:off x="4708072" y="2298747"/>
            <a:ext cx="6783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Control</a:t>
            </a:r>
            <a:endParaRPr lang="en-US" altLang="ja-JP" sz="12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47" name="正方形/長方形 29"/>
          <p:cNvSpPr>
            <a:spLocks noChangeArrowheads="1"/>
          </p:cNvSpPr>
          <p:nvPr/>
        </p:nvSpPr>
        <p:spPr bwMode="auto">
          <a:xfrm>
            <a:off x="1072061" y="3413899"/>
            <a:ext cx="1011815" cy="461665"/>
          </a:xfrm>
          <a:prstGeom prst="rect">
            <a:avLst/>
          </a:prstGeom>
          <a:noFill/>
          <a:ln w="158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1st shading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treatment</a:t>
            </a:r>
          </a:p>
        </p:txBody>
      </p:sp>
      <p:sp>
        <p:nvSpPr>
          <p:cNvPr id="48" name="正方形/長方形 29"/>
          <p:cNvSpPr>
            <a:spLocks noChangeArrowheads="1"/>
          </p:cNvSpPr>
          <p:nvPr/>
        </p:nvSpPr>
        <p:spPr bwMode="auto">
          <a:xfrm>
            <a:off x="2842159" y="3413899"/>
            <a:ext cx="1061508" cy="461665"/>
          </a:xfrm>
          <a:prstGeom prst="rect">
            <a:avLst/>
          </a:prstGeom>
          <a:noFill/>
          <a:ln w="158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2nd shading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treatment</a:t>
            </a:r>
          </a:p>
        </p:txBody>
      </p:sp>
      <p:sp>
        <p:nvSpPr>
          <p:cNvPr id="49" name="正方形/長方形 29"/>
          <p:cNvSpPr>
            <a:spLocks noChangeArrowheads="1"/>
          </p:cNvSpPr>
          <p:nvPr/>
        </p:nvSpPr>
        <p:spPr bwMode="auto">
          <a:xfrm>
            <a:off x="4559256" y="3413899"/>
            <a:ext cx="1027845" cy="461665"/>
          </a:xfrm>
          <a:prstGeom prst="rect">
            <a:avLst/>
          </a:prstGeom>
          <a:noFill/>
          <a:ln w="1587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3rd shading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solidFill>
                  <a:prstClr val="black"/>
                </a:solidFill>
                <a:cs typeface="Arial" panose="020B0604020202020204" pitchFamily="34" charset="0"/>
              </a:rPr>
              <a:t>treatment</a:t>
            </a:r>
          </a:p>
        </p:txBody>
      </p:sp>
      <p:sp>
        <p:nvSpPr>
          <p:cNvPr id="50" name="正方形/長方形 33"/>
          <p:cNvSpPr>
            <a:spLocks noChangeArrowheads="1"/>
          </p:cNvSpPr>
          <p:nvPr/>
        </p:nvSpPr>
        <p:spPr bwMode="auto">
          <a:xfrm>
            <a:off x="1327027" y="2645696"/>
            <a:ext cx="4587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14 d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1" name="正方形/長方形 33"/>
          <p:cNvSpPr>
            <a:spLocks noChangeArrowheads="1"/>
          </p:cNvSpPr>
          <p:nvPr/>
        </p:nvSpPr>
        <p:spPr bwMode="auto">
          <a:xfrm>
            <a:off x="2198420" y="2645696"/>
            <a:ext cx="4587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28 d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2" name="正方形/長方形 33"/>
          <p:cNvSpPr>
            <a:spLocks noChangeArrowheads="1"/>
          </p:cNvSpPr>
          <p:nvPr/>
        </p:nvSpPr>
        <p:spPr bwMode="auto">
          <a:xfrm>
            <a:off x="3093972" y="2645696"/>
            <a:ext cx="4587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15 d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3" name="正方形/長方形 33"/>
          <p:cNvSpPr>
            <a:spLocks noChangeArrowheads="1"/>
          </p:cNvSpPr>
          <p:nvPr/>
        </p:nvSpPr>
        <p:spPr bwMode="auto">
          <a:xfrm>
            <a:off x="3976385" y="2645696"/>
            <a:ext cx="4203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33d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4" name="正方形/長方形 33"/>
          <p:cNvSpPr>
            <a:spLocks noChangeArrowheads="1"/>
          </p:cNvSpPr>
          <p:nvPr/>
        </p:nvSpPr>
        <p:spPr bwMode="auto">
          <a:xfrm>
            <a:off x="4814340" y="2645696"/>
            <a:ext cx="4587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16 d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8" name="正方形/長方形 33"/>
          <p:cNvSpPr>
            <a:spLocks noChangeArrowheads="1"/>
          </p:cNvSpPr>
          <p:nvPr/>
        </p:nvSpPr>
        <p:spPr bwMode="auto">
          <a:xfrm>
            <a:off x="1184237" y="1282580"/>
            <a:ext cx="1667750" cy="1084421"/>
          </a:xfrm>
          <a:prstGeom prst="downArrowCallout">
            <a:avLst>
              <a:gd name="adj1" fmla="val 17973"/>
              <a:gd name="adj2" fmla="val 25000"/>
              <a:gd name="adj3" fmla="val 23504"/>
              <a:gd name="adj4" fmla="val 64977"/>
            </a:avLst>
          </a:prstGeom>
          <a:solidFill>
            <a:schemeClr val="bg1">
              <a:lumMod val="95000"/>
            </a:schemeClr>
          </a:solidFill>
          <a:ln w="15875">
            <a:solidFill>
              <a:schemeClr val="tx1"/>
            </a:solidFill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ja-JP" altLang="en-US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・</a:t>
            </a: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Sampling of new shoot</a:t>
            </a:r>
            <a:r>
              <a:rPr lang="ja-JP" altLang="en-US" sz="10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endParaRPr lang="en-US" altLang="ja-JP" sz="1000" dirty="0" smtClean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(n=6)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ja-JP" altLang="en-US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・</a:t>
            </a: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Sampling of whole plants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(n=1)</a:t>
            </a:r>
            <a:endParaRPr lang="en-US" altLang="ja-JP" sz="10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0" name="正方形/長方形 33"/>
          <p:cNvSpPr>
            <a:spLocks noChangeArrowheads="1"/>
          </p:cNvSpPr>
          <p:nvPr/>
        </p:nvSpPr>
        <p:spPr bwMode="auto">
          <a:xfrm>
            <a:off x="5579608" y="2539504"/>
            <a:ext cx="936475" cy="577081"/>
          </a:xfrm>
          <a:prstGeom prst="rect">
            <a:avLst/>
          </a:prstGeom>
          <a:solidFill>
            <a:schemeClr val="bg1">
              <a:lumMod val="95000"/>
            </a:schemeClr>
          </a:solidFill>
          <a:ln w="15875">
            <a:solidFill>
              <a:schemeClr val="tx1"/>
            </a:solidFill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Sampling of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whole plants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(n=3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1" name="正方形/長方形 33"/>
          <p:cNvSpPr>
            <a:spLocks noChangeArrowheads="1"/>
          </p:cNvSpPr>
          <p:nvPr/>
        </p:nvSpPr>
        <p:spPr bwMode="auto">
          <a:xfrm>
            <a:off x="3067240" y="588764"/>
            <a:ext cx="1454244" cy="415498"/>
          </a:xfrm>
          <a:prstGeom prst="rect">
            <a:avLst/>
          </a:prstGeom>
          <a:solidFill>
            <a:schemeClr val="bg1">
              <a:lumMod val="95000"/>
            </a:schemeClr>
          </a:solidFill>
          <a:ln w="15875">
            <a:solidFill>
              <a:schemeClr val="tx1"/>
            </a:solidFill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Metabolome analysis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of whole plants (n=1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2" name="右矢印 61"/>
          <p:cNvSpPr/>
          <p:nvPr/>
        </p:nvSpPr>
        <p:spPr bwMode="auto">
          <a:xfrm rot="16200000">
            <a:off x="3691183" y="972369"/>
            <a:ext cx="172115" cy="264460"/>
          </a:xfrm>
          <a:prstGeom prst="rightArrow">
            <a:avLst/>
          </a:prstGeom>
          <a:solidFill>
            <a:schemeClr val="bg1">
              <a:lumMod val="9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正方形/長方形 75"/>
          <p:cNvSpPr/>
          <p:nvPr/>
        </p:nvSpPr>
        <p:spPr>
          <a:xfrm>
            <a:off x="2811384" y="5497128"/>
            <a:ext cx="1874201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正方形/長方形 33"/>
          <p:cNvSpPr>
            <a:spLocks noChangeArrowheads="1"/>
          </p:cNvSpPr>
          <p:nvPr/>
        </p:nvSpPr>
        <p:spPr bwMode="auto">
          <a:xfrm>
            <a:off x="3991608" y="5259956"/>
            <a:ext cx="83548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Trunk (TR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4" name="正方形/長方形 73"/>
          <p:cNvSpPr/>
          <p:nvPr/>
        </p:nvSpPr>
        <p:spPr>
          <a:xfrm>
            <a:off x="2527867" y="5247738"/>
            <a:ext cx="2157718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/>
          <p:cNvSpPr/>
          <p:nvPr/>
        </p:nvSpPr>
        <p:spPr>
          <a:xfrm>
            <a:off x="2487306" y="4386277"/>
            <a:ext cx="1107250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33"/>
          <p:cNvSpPr>
            <a:spLocks noChangeArrowheads="1"/>
          </p:cNvSpPr>
          <p:nvPr/>
        </p:nvSpPr>
        <p:spPr bwMode="auto">
          <a:xfrm>
            <a:off x="2474937" y="4155581"/>
            <a:ext cx="1183337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Ne</a:t>
            </a:r>
            <a:r>
              <a:rPr lang="en-US" altLang="ja-JP" sz="1050" dirty="0">
                <a:solidFill>
                  <a:prstClr val="black"/>
                </a:solidFill>
                <a:cs typeface="Arial" panose="020B0604020202020204" pitchFamily="34" charset="0"/>
              </a:rPr>
              <a:t>w</a:t>
            </a: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 leaves (NL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5" name="正方形/長方形 33"/>
          <p:cNvSpPr>
            <a:spLocks noChangeArrowheads="1"/>
          </p:cNvSpPr>
          <p:nvPr/>
        </p:nvSpPr>
        <p:spPr bwMode="auto">
          <a:xfrm>
            <a:off x="807150" y="4352394"/>
            <a:ext cx="116570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New stems (NS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858765" y="4587050"/>
            <a:ext cx="1473750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/>
          <p:cNvSpPr/>
          <p:nvPr/>
        </p:nvSpPr>
        <p:spPr>
          <a:xfrm>
            <a:off x="724800" y="4954010"/>
            <a:ext cx="1267431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33"/>
          <p:cNvSpPr>
            <a:spLocks noChangeArrowheads="1"/>
          </p:cNvSpPr>
          <p:nvPr/>
        </p:nvSpPr>
        <p:spPr bwMode="auto">
          <a:xfrm>
            <a:off x="659167" y="4723314"/>
            <a:ext cx="134684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Mature leaves (ML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pic>
        <p:nvPicPr>
          <p:cNvPr id="69" name="図 6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2368" y="4277776"/>
            <a:ext cx="1779320" cy="3399244"/>
          </a:xfrm>
          <a:prstGeom prst="rect">
            <a:avLst/>
          </a:prstGeom>
        </p:spPr>
      </p:pic>
      <p:sp>
        <p:nvSpPr>
          <p:cNvPr id="70" name="正方形/長方形 69"/>
          <p:cNvSpPr/>
          <p:nvPr/>
        </p:nvSpPr>
        <p:spPr>
          <a:xfrm>
            <a:off x="530314" y="5350393"/>
            <a:ext cx="1548927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33"/>
          <p:cNvSpPr>
            <a:spLocks noChangeArrowheads="1"/>
          </p:cNvSpPr>
          <p:nvPr/>
        </p:nvSpPr>
        <p:spPr bwMode="auto">
          <a:xfrm>
            <a:off x="437789" y="5119697"/>
            <a:ext cx="175080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Very mature leaves (VML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2" name="正方形/長方形 71"/>
          <p:cNvSpPr/>
          <p:nvPr/>
        </p:nvSpPr>
        <p:spPr>
          <a:xfrm>
            <a:off x="2365783" y="4910745"/>
            <a:ext cx="1339773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3" name="正方形/長方形 33"/>
          <p:cNvSpPr>
            <a:spLocks noChangeArrowheads="1"/>
          </p:cNvSpPr>
          <p:nvPr/>
        </p:nvSpPr>
        <p:spPr bwMode="auto">
          <a:xfrm>
            <a:off x="2415848" y="4679843"/>
            <a:ext cx="132921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Mature stems (MS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5" name="正方形/長方形 33"/>
          <p:cNvSpPr>
            <a:spLocks noChangeArrowheads="1"/>
          </p:cNvSpPr>
          <p:nvPr/>
        </p:nvSpPr>
        <p:spPr bwMode="auto">
          <a:xfrm>
            <a:off x="3696210" y="5010566"/>
            <a:ext cx="106952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Branches (BR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8" name="正方形/長方形 77"/>
          <p:cNvSpPr/>
          <p:nvPr/>
        </p:nvSpPr>
        <p:spPr>
          <a:xfrm>
            <a:off x="874363" y="6954346"/>
            <a:ext cx="1533591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33"/>
          <p:cNvSpPr>
            <a:spLocks noChangeArrowheads="1"/>
          </p:cNvSpPr>
          <p:nvPr/>
        </p:nvSpPr>
        <p:spPr bwMode="auto">
          <a:xfrm>
            <a:off x="817994" y="6723650"/>
            <a:ext cx="139333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cs typeface="Arial" panose="020B0604020202020204" pitchFamily="34" charset="0"/>
              </a:rPr>
              <a:t>Lignifying roots</a:t>
            </a: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 (LR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0" name="正方形/長方形 79"/>
          <p:cNvSpPr/>
          <p:nvPr/>
        </p:nvSpPr>
        <p:spPr>
          <a:xfrm>
            <a:off x="3134963" y="7316296"/>
            <a:ext cx="1533591" cy="1545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正方形/長方形 33"/>
          <p:cNvSpPr>
            <a:spLocks noChangeArrowheads="1"/>
          </p:cNvSpPr>
          <p:nvPr/>
        </p:nvSpPr>
        <p:spPr bwMode="auto">
          <a:xfrm>
            <a:off x="3516756" y="7085600"/>
            <a:ext cx="11144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50" dirty="0" smtClean="0">
                <a:cs typeface="Arial" panose="020B0604020202020204" pitchFamily="34" charset="0"/>
              </a:rPr>
              <a:t>New roots</a:t>
            </a:r>
            <a:r>
              <a:rPr lang="en-US" altLang="ja-JP" sz="1050" dirty="0" smtClean="0">
                <a:solidFill>
                  <a:prstClr val="black"/>
                </a:solidFill>
                <a:cs typeface="Arial" panose="020B0604020202020204" pitchFamily="34" charset="0"/>
              </a:rPr>
              <a:t> (NR)</a:t>
            </a:r>
            <a:endParaRPr lang="en-US" altLang="ja-JP" sz="105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131692" y="461340"/>
            <a:ext cx="749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134866" y="4026778"/>
            <a:ext cx="749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319183" y="8050183"/>
            <a:ext cx="620393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1.  Overview of repeated shading treatment of pot-grown immature tea plants in the growth chamber. </a:t>
            </a:r>
            <a:endParaRPr lang="ja-JP" altLang="ja-JP" sz="12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Experimental design of the repeated shading treatment test. (B) Organs of immature tea plants separated by sampling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86" name="正方形/長方形 33"/>
          <p:cNvSpPr>
            <a:spLocks noChangeArrowheads="1"/>
          </p:cNvSpPr>
          <p:nvPr/>
        </p:nvSpPr>
        <p:spPr bwMode="auto">
          <a:xfrm>
            <a:off x="2937607" y="1272838"/>
            <a:ext cx="1667750" cy="1084421"/>
          </a:xfrm>
          <a:prstGeom prst="downArrowCallout">
            <a:avLst>
              <a:gd name="adj1" fmla="val 17973"/>
              <a:gd name="adj2" fmla="val 25000"/>
              <a:gd name="adj3" fmla="val 23504"/>
              <a:gd name="adj4" fmla="val 64977"/>
            </a:avLst>
          </a:prstGeom>
          <a:solidFill>
            <a:schemeClr val="bg1">
              <a:lumMod val="95000"/>
            </a:schemeClr>
          </a:solidFill>
          <a:ln w="15875">
            <a:solidFill>
              <a:schemeClr val="tx1"/>
            </a:solidFill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ja-JP" altLang="en-US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・</a:t>
            </a: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Sampling of new shoot</a:t>
            </a:r>
            <a:r>
              <a:rPr lang="ja-JP" altLang="en-US" sz="1000" dirty="0">
                <a:solidFill>
                  <a:prstClr val="black"/>
                </a:solidFill>
                <a:cs typeface="Arial" panose="020B0604020202020204" pitchFamily="34" charset="0"/>
              </a:rPr>
              <a:t> </a:t>
            </a:r>
            <a:endParaRPr lang="en-US" altLang="ja-JP" sz="1000" dirty="0" smtClean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(n=5)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ja-JP" altLang="en-US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・</a:t>
            </a: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Sampling of whole plants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solidFill>
                  <a:prstClr val="black"/>
                </a:solidFill>
                <a:cs typeface="Arial" panose="020B0604020202020204" pitchFamily="34" charset="0"/>
              </a:rPr>
              <a:t>(n=1)</a:t>
            </a:r>
            <a:endParaRPr lang="en-US" altLang="ja-JP" sz="10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3732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グループ化 45"/>
          <p:cNvGrpSpPr/>
          <p:nvPr/>
        </p:nvGrpSpPr>
        <p:grpSpPr>
          <a:xfrm>
            <a:off x="530569" y="1588032"/>
            <a:ext cx="5377862" cy="5368230"/>
            <a:chOff x="237492" y="1459078"/>
            <a:chExt cx="5377862" cy="5368230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 rotWithShape="1">
            <a:blip r:embed="rId2"/>
            <a:srcRect t="26140" r="15437" b="14901"/>
            <a:stretch/>
          </p:blipFill>
          <p:spPr>
            <a:xfrm>
              <a:off x="237492" y="2661138"/>
              <a:ext cx="5377862" cy="3751385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3"/>
            <a:srcRect l="7132" r="72877" b="76914"/>
            <a:stretch/>
          </p:blipFill>
          <p:spPr>
            <a:xfrm>
              <a:off x="4102011" y="1459078"/>
              <a:ext cx="1513343" cy="1202060"/>
            </a:xfrm>
            <a:prstGeom prst="rect">
              <a:avLst/>
            </a:prstGeom>
          </p:spPr>
        </p:pic>
        <p:grpSp>
          <p:nvGrpSpPr>
            <p:cNvPr id="20" name="グループ化 19"/>
            <p:cNvGrpSpPr/>
            <p:nvPr/>
          </p:nvGrpSpPr>
          <p:grpSpPr>
            <a:xfrm>
              <a:off x="1954663" y="6318656"/>
              <a:ext cx="592609" cy="508652"/>
              <a:chOff x="1964189" y="6332945"/>
              <a:chExt cx="592609" cy="508652"/>
            </a:xfrm>
          </p:grpSpPr>
          <p:sp>
            <p:nvSpPr>
              <p:cNvPr id="13" name="テキスト ボックス 12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正方形/長方形 16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グループ化 20"/>
            <p:cNvGrpSpPr/>
            <p:nvPr/>
          </p:nvGrpSpPr>
          <p:grpSpPr>
            <a:xfrm>
              <a:off x="2564457" y="6318656"/>
              <a:ext cx="592609" cy="508652"/>
              <a:chOff x="1964189" y="6332945"/>
              <a:chExt cx="592609" cy="508652"/>
            </a:xfrm>
          </p:grpSpPr>
          <p:sp>
            <p:nvSpPr>
              <p:cNvPr id="22" name="テキスト ボックス 21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正方形/長方形 22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グループ化 25"/>
            <p:cNvGrpSpPr/>
            <p:nvPr/>
          </p:nvGrpSpPr>
          <p:grpSpPr>
            <a:xfrm>
              <a:off x="3174251" y="6318656"/>
              <a:ext cx="592609" cy="508652"/>
              <a:chOff x="1964189" y="6332945"/>
              <a:chExt cx="592609" cy="508652"/>
            </a:xfrm>
          </p:grpSpPr>
          <p:sp>
            <p:nvSpPr>
              <p:cNvPr id="27" name="テキスト ボックス 26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R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" name="グループ化 30"/>
            <p:cNvGrpSpPr/>
            <p:nvPr/>
          </p:nvGrpSpPr>
          <p:grpSpPr>
            <a:xfrm>
              <a:off x="3784045" y="6318656"/>
              <a:ext cx="592609" cy="508652"/>
              <a:chOff x="1964189" y="6332945"/>
              <a:chExt cx="592609" cy="508652"/>
            </a:xfrm>
          </p:grpSpPr>
          <p:sp>
            <p:nvSpPr>
              <p:cNvPr id="32" name="テキスト ボックス 31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正方形/長方形 32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6" name="グループ化 35"/>
            <p:cNvGrpSpPr/>
            <p:nvPr/>
          </p:nvGrpSpPr>
          <p:grpSpPr>
            <a:xfrm>
              <a:off x="4393839" y="6318656"/>
              <a:ext cx="592609" cy="508652"/>
              <a:chOff x="1964189" y="6332945"/>
              <a:chExt cx="592609" cy="508652"/>
            </a:xfrm>
          </p:grpSpPr>
          <p:sp>
            <p:nvSpPr>
              <p:cNvPr id="37" name="テキスト ボックス 36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正方形/長方形 37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テキスト ボックス 38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1" name="グループ化 40"/>
            <p:cNvGrpSpPr/>
            <p:nvPr/>
          </p:nvGrpSpPr>
          <p:grpSpPr>
            <a:xfrm>
              <a:off x="5003631" y="6318656"/>
              <a:ext cx="592609" cy="508652"/>
              <a:chOff x="1964189" y="6332945"/>
              <a:chExt cx="592609" cy="508652"/>
            </a:xfrm>
          </p:grpSpPr>
          <p:sp>
            <p:nvSpPr>
              <p:cNvPr id="42" name="テキスト ボックス 41"/>
              <p:cNvSpPr txBox="1"/>
              <p:nvPr/>
            </p:nvSpPr>
            <p:spPr>
              <a:xfrm>
                <a:off x="2107481" y="6579987"/>
                <a:ext cx="4163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R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正方形/長方形 42"/>
              <p:cNvSpPr/>
              <p:nvPr/>
            </p:nvSpPr>
            <p:spPr>
              <a:xfrm>
                <a:off x="1973097" y="6579987"/>
                <a:ext cx="583701" cy="1456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1964189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/>
              <p:cNvSpPr txBox="1"/>
              <p:nvPr/>
            </p:nvSpPr>
            <p:spPr>
              <a:xfrm>
                <a:off x="2269085" y="6332945"/>
                <a:ext cx="2503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7" name="テキスト ボックス 46"/>
          <p:cNvSpPr txBox="1"/>
          <p:nvPr/>
        </p:nvSpPr>
        <p:spPr>
          <a:xfrm>
            <a:off x="530569" y="7109437"/>
            <a:ext cx="53778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2.  Effect of repeated shading treatment on metabolome profile in major organs of pot-grown immature tea plants in the growth chamber. 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27492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右矢印 1"/>
          <p:cNvSpPr/>
          <p:nvPr/>
        </p:nvSpPr>
        <p:spPr bwMode="auto">
          <a:xfrm>
            <a:off x="651390" y="3061360"/>
            <a:ext cx="653613" cy="16420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32464" y="4435616"/>
            <a:ext cx="1175876" cy="3693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ud opening </a:t>
            </a:r>
          </a:p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first crop seaso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右矢印 3"/>
          <p:cNvSpPr/>
          <p:nvPr/>
        </p:nvSpPr>
        <p:spPr bwMode="auto">
          <a:xfrm>
            <a:off x="1329611" y="3061360"/>
            <a:ext cx="335406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右矢印 4"/>
          <p:cNvSpPr/>
          <p:nvPr/>
        </p:nvSpPr>
        <p:spPr bwMode="auto">
          <a:xfrm>
            <a:off x="1689625" y="3061359"/>
            <a:ext cx="335406" cy="16420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右矢印 5"/>
          <p:cNvSpPr/>
          <p:nvPr/>
        </p:nvSpPr>
        <p:spPr bwMode="auto">
          <a:xfrm>
            <a:off x="2049639" y="3061359"/>
            <a:ext cx="335406" cy="16420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右矢印 6"/>
          <p:cNvSpPr/>
          <p:nvPr/>
        </p:nvSpPr>
        <p:spPr bwMode="auto">
          <a:xfrm>
            <a:off x="2409652" y="3061358"/>
            <a:ext cx="1013625" cy="168875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右矢印 7"/>
          <p:cNvSpPr/>
          <p:nvPr/>
        </p:nvSpPr>
        <p:spPr bwMode="auto">
          <a:xfrm>
            <a:off x="3447888" y="3061360"/>
            <a:ext cx="335406" cy="16420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右矢印 8"/>
          <p:cNvSpPr/>
          <p:nvPr/>
        </p:nvSpPr>
        <p:spPr bwMode="auto">
          <a:xfrm>
            <a:off x="3807902" y="3061359"/>
            <a:ext cx="335406" cy="16420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右矢印 9"/>
          <p:cNvSpPr/>
          <p:nvPr/>
        </p:nvSpPr>
        <p:spPr bwMode="auto">
          <a:xfrm>
            <a:off x="4167918" y="3061359"/>
            <a:ext cx="335406" cy="16420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914784" y="3714256"/>
            <a:ext cx="1479159" cy="61555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ud opening </a:t>
            </a:r>
          </a:p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first crop season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altLang="ja-JP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ch measurement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altLang="ja-JP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ja-JP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abolome analysis</a:t>
            </a:r>
            <a:endParaRPr lang="ja-JP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二等辺三角形 14"/>
          <p:cNvSpPr/>
          <p:nvPr/>
        </p:nvSpPr>
        <p:spPr>
          <a:xfrm rot="10800000">
            <a:off x="3217079" y="2919624"/>
            <a:ext cx="152043" cy="136666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二等辺三角形 15"/>
          <p:cNvSpPr/>
          <p:nvPr/>
        </p:nvSpPr>
        <p:spPr>
          <a:xfrm rot="10800000">
            <a:off x="4769564" y="2919624"/>
            <a:ext cx="152043" cy="136666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169180" y="3185997"/>
            <a:ext cx="624971" cy="50783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st crop season</a:t>
            </a:r>
          </a:p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30 d)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859936" y="3185997"/>
            <a:ext cx="669556" cy="3693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d crop season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313034" y="3180312"/>
            <a:ext cx="624971" cy="3693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st crop season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03790" y="3180312"/>
            <a:ext cx="669556" cy="3693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d crop season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下矢印 22"/>
          <p:cNvSpPr/>
          <p:nvPr/>
        </p:nvSpPr>
        <p:spPr>
          <a:xfrm rot="10800000" flipH="1">
            <a:off x="3233946" y="3241676"/>
            <a:ext cx="111706" cy="520924"/>
          </a:xfrm>
          <a:prstGeom prst="downArrow">
            <a:avLst>
              <a:gd name="adj1" fmla="val 37714"/>
              <a:gd name="adj2" fmla="val 53420"/>
            </a:avLst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コネクタ 24"/>
          <p:cNvCxnSpPr/>
          <p:nvPr/>
        </p:nvCxnSpPr>
        <p:spPr>
          <a:xfrm>
            <a:off x="2956631" y="2676391"/>
            <a:ext cx="0" cy="1159312"/>
          </a:xfrm>
          <a:prstGeom prst="line">
            <a:avLst/>
          </a:prstGeom>
          <a:ln w="19050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/>
          <p:cNvSpPr txBox="1"/>
          <p:nvPr/>
        </p:nvSpPr>
        <p:spPr>
          <a:xfrm>
            <a:off x="332701" y="3553042"/>
            <a:ext cx="1050757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i="1" u="sng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1 ~ 2016 (6y)</a:t>
            </a:r>
            <a:endParaRPr lang="ja-JP" altLang="en-US" sz="900" i="1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905478" y="2616437"/>
            <a:ext cx="459587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i="1" u="sng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7</a:t>
            </a:r>
            <a:endParaRPr lang="ja-JP" altLang="en-US" sz="900" i="1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右矢印 27"/>
          <p:cNvSpPr/>
          <p:nvPr/>
        </p:nvSpPr>
        <p:spPr bwMode="auto">
          <a:xfrm>
            <a:off x="3098172" y="4782393"/>
            <a:ext cx="172115" cy="112157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二等辺三角形 28"/>
          <p:cNvSpPr/>
          <p:nvPr/>
        </p:nvSpPr>
        <p:spPr>
          <a:xfrm rot="10800000">
            <a:off x="3120763" y="4613205"/>
            <a:ext cx="114232" cy="112947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07050" y="4721397"/>
            <a:ext cx="966772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ding period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207050" y="4551782"/>
            <a:ext cx="966772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ling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3046952" y="4576589"/>
            <a:ext cx="1061949" cy="357230"/>
          </a:xfrm>
          <a:prstGeom prst="rect">
            <a:avLst/>
          </a:prstGeom>
          <a:noFill/>
          <a:ln w="15875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右矢印 32"/>
          <p:cNvSpPr/>
          <p:nvPr/>
        </p:nvSpPr>
        <p:spPr bwMode="auto">
          <a:xfrm>
            <a:off x="4537079" y="3056291"/>
            <a:ext cx="1013625" cy="168875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下カーブ矢印 33"/>
          <p:cNvSpPr/>
          <p:nvPr/>
        </p:nvSpPr>
        <p:spPr>
          <a:xfrm>
            <a:off x="759884" y="2351761"/>
            <a:ext cx="2154900" cy="450475"/>
          </a:xfrm>
          <a:prstGeom prst="curvedDownArrow">
            <a:avLst>
              <a:gd name="adj1" fmla="val 18220"/>
              <a:gd name="adj2" fmla="val 50000"/>
              <a:gd name="adj3" fmla="val 30740"/>
            </a:avLst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7" name="下カーブ矢印 36"/>
          <p:cNvSpPr/>
          <p:nvPr/>
        </p:nvSpPr>
        <p:spPr>
          <a:xfrm rot="10800000">
            <a:off x="750577" y="4819441"/>
            <a:ext cx="2154900" cy="450475"/>
          </a:xfrm>
          <a:prstGeom prst="curvedDownArrow">
            <a:avLst>
              <a:gd name="adj1" fmla="val 18220"/>
              <a:gd name="adj2" fmla="val 50000"/>
              <a:gd name="adj3" fmla="val 30740"/>
            </a:avLst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478975" y="3714256"/>
            <a:ext cx="2500945" cy="600164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-summer season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altLang="ja-JP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ja-JP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opy temperature measurement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altLang="ja-JP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ch </a:t>
            </a:r>
            <a:r>
              <a:rPr lang="en-US" altLang="ja-JP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ment</a:t>
            </a:r>
          </a:p>
          <a:p>
            <a:pPr marL="171450" indent="-171450">
              <a:buFont typeface="Wingdings" panose="05000000000000000000" pitchFamily="2" charset="2"/>
              <a:buChar char="l"/>
            </a:pPr>
            <a:r>
              <a:rPr lang="en-US" altLang="ja-JP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abolome analysis</a:t>
            </a:r>
            <a:endParaRPr lang="ja-JP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下矢印 39"/>
          <p:cNvSpPr/>
          <p:nvPr/>
        </p:nvSpPr>
        <p:spPr>
          <a:xfrm rot="10800000" flipH="1">
            <a:off x="4798137" y="3241676"/>
            <a:ext cx="111706" cy="520924"/>
          </a:xfrm>
          <a:prstGeom prst="downArrow">
            <a:avLst>
              <a:gd name="adj1" fmla="val 37714"/>
              <a:gd name="adj2" fmla="val 53420"/>
            </a:avLst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32700" y="5441528"/>
            <a:ext cx="61061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3.  Experimental design to evaluate the effect of repeated shading on tea ridges showing accumulated damage from shading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1" name="右矢印 50"/>
          <p:cNvSpPr/>
          <p:nvPr/>
        </p:nvSpPr>
        <p:spPr bwMode="auto">
          <a:xfrm>
            <a:off x="651390" y="3784528"/>
            <a:ext cx="653613" cy="164209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右矢印 51"/>
          <p:cNvSpPr/>
          <p:nvPr/>
        </p:nvSpPr>
        <p:spPr bwMode="auto">
          <a:xfrm>
            <a:off x="1329611" y="3784528"/>
            <a:ext cx="335406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右矢印 52"/>
          <p:cNvSpPr/>
          <p:nvPr/>
        </p:nvSpPr>
        <p:spPr bwMode="auto">
          <a:xfrm>
            <a:off x="1689625" y="3784527"/>
            <a:ext cx="335406" cy="164209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右矢印 53"/>
          <p:cNvSpPr/>
          <p:nvPr/>
        </p:nvSpPr>
        <p:spPr bwMode="auto">
          <a:xfrm>
            <a:off x="2049639" y="3784527"/>
            <a:ext cx="335406" cy="164209"/>
          </a:xfrm>
          <a:prstGeom prst="rightArrow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n w="19050"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169180" y="3909165"/>
            <a:ext cx="624971" cy="50783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st crop season</a:t>
            </a:r>
          </a:p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30 d)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859936" y="3909165"/>
            <a:ext cx="669556" cy="50783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d crop season</a:t>
            </a:r>
          </a:p>
          <a:p>
            <a:pPr algn="ctr"/>
            <a:r>
              <a:rPr lang="en-US" altLang="ja-JP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0 d)</a:t>
            </a:r>
            <a:endParaRPr lang="ja-JP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下矢印 56"/>
          <p:cNvSpPr/>
          <p:nvPr/>
        </p:nvSpPr>
        <p:spPr>
          <a:xfrm rot="10800000" flipH="1">
            <a:off x="1061624" y="3964844"/>
            <a:ext cx="111706" cy="520924"/>
          </a:xfrm>
          <a:prstGeom prst="downArrow">
            <a:avLst>
              <a:gd name="adj1" fmla="val 37714"/>
              <a:gd name="adj2" fmla="val 53420"/>
            </a:avLst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2331492" y="3763276"/>
            <a:ext cx="781292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ja-JP" altLang="en-US" sz="9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・・・・・・・・</a:t>
            </a:r>
            <a:endParaRPr lang="ja-JP" altLang="en-US" sz="9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32702" y="2852213"/>
            <a:ext cx="1050756" cy="2308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900" i="1" u="sng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4 ~ 2016 (3y)</a:t>
            </a:r>
            <a:endParaRPr lang="ja-JP" altLang="en-US" sz="900" i="1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499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4567395"/>
              </p:ext>
            </p:extLst>
          </p:nvPr>
        </p:nvGraphicFramePr>
        <p:xfrm>
          <a:off x="3623291" y="2089214"/>
          <a:ext cx="2063218" cy="173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7554055"/>
              </p:ext>
            </p:extLst>
          </p:nvPr>
        </p:nvGraphicFramePr>
        <p:xfrm>
          <a:off x="1403434" y="2089214"/>
          <a:ext cx="1854527" cy="173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 rot="16200000">
            <a:off x="369986" y="2683142"/>
            <a:ext cx="1649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tal Fe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ent</a:t>
            </a:r>
          </a:p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mg g</a:t>
            </a:r>
            <a:r>
              <a:rPr lang="en-US" altLang="ja-JP" sz="1200" baseline="300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−1</a:t>
            </a:r>
            <a:r>
              <a:rPr lang="en-US" altLang="ja-JP" sz="12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DW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2615867" y="2683142"/>
            <a:ext cx="1649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tal Mg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ent</a:t>
            </a:r>
          </a:p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mg g</a:t>
            </a:r>
            <a:r>
              <a:rPr lang="en-US" altLang="ja-JP" sz="1200" baseline="300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−1</a:t>
            </a:r>
            <a:r>
              <a:rPr lang="en-US" altLang="ja-JP" sz="1200" dirty="0" smtClean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DW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009758" y="3880652"/>
            <a:ext cx="10962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eaves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734058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207111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691665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rd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722147" y="3908245"/>
            <a:ext cx="1382121" cy="1456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445127" y="3880652"/>
            <a:ext cx="10962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eaves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159902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st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632955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nd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117509" y="3675235"/>
            <a:ext cx="416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rd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4147991" y="3908245"/>
            <a:ext cx="1382121" cy="1456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96662" y="4437696"/>
            <a:ext cx="49326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4.  Effect of repeated shading treatment on iron (Fe) and magnesium (Mg) contents in new leaves of immature tea plants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4948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33</TotalTime>
  <Words>378</Words>
  <Application>Microsoft Office PowerPoint</Application>
  <PresentationFormat>A4 210 x 297 mm</PresentationFormat>
  <Paragraphs>10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2" baseType="lpstr">
      <vt:lpstr>ＭＳ Ｐゴシック</vt:lpstr>
      <vt:lpstr>ＭＳ 明朝</vt:lpstr>
      <vt:lpstr>Arial</vt:lpstr>
      <vt:lpstr>Calibri</vt:lpstr>
      <vt:lpstr>Calibri Light</vt:lpstr>
      <vt:lpstr>Times New Roman</vt:lpstr>
      <vt:lpstr>Wingdings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to YAMASHITA</dc:creator>
  <cp:lastModifiedBy>Hiroto YAMASHITA</cp:lastModifiedBy>
  <cp:revision>193</cp:revision>
  <cp:lastPrinted>2020-02-18T02:56:38Z</cp:lastPrinted>
  <dcterms:created xsi:type="dcterms:W3CDTF">2020-02-05T07:44:23Z</dcterms:created>
  <dcterms:modified xsi:type="dcterms:W3CDTF">2020-04-26T06:44:25Z</dcterms:modified>
</cp:coreProperties>
</file>